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106BEE-A911-10C3-FE53-224DF5EA6E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785A450-C7E6-3008-F383-42659ED1EB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FE06FF-BDA4-89AD-C5F9-02C2FB30A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D409CA-6A8B-76C3-821A-0D3C2B762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8382AC-9363-AF32-C9D4-F7E9BF36C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694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480FCE-91DF-A1CD-6601-665F0C13B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9867FC3-C40C-95F3-51A0-64D12BB4D4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7D5616-60FD-1B5E-5B5C-13DF707B9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37E86D-523D-9AB4-E7C4-AFB8DBD22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F8232E-0AE0-DA76-D50A-96108587E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0931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902997D-674A-7E12-A156-87A83BCA41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65B967D-3BB6-ED31-3FDE-6A0422A42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438317-04AF-62E9-9367-17FF0C87D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CB9DF3-9CE6-C4B9-0920-0B1F0931F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EC22DF-F632-6DDF-6813-8313E00AF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47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F2A581-43A4-6BC5-A65B-C34DE810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F1FD36-6BE6-A6F9-1C97-A4CB3611BE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1038B9-FE60-57CE-7EF7-2BB46DF59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F4BDE1-8B17-6BE4-9069-96C26225D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360A71-38E4-E07E-54BB-79BC16B4A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72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ECFF7-76DC-5052-1DD6-0335D7FFC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D807E1-A4FD-CC32-6288-8F0463E6F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ED91F9-225B-5CB4-6A08-378E0AFED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5EAB80-158C-6B5D-71A5-1DF9196FE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CED456-6051-5A96-EBD7-A0EF081ED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239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F93258-BC65-6970-EDC3-A482FBB764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DFB0A5-B0CF-F49A-F3FB-F15BB6CC3F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57AD84-32BE-B351-FB05-294AED4D8B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1BEC015-D719-F6C1-2A9C-5E066DE56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B9A36A4-B218-070F-3A5A-08D3E5222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A4D21F5-F742-D732-9251-870344EDD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599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8ADA7F-7DDB-F1FE-191E-C44817BEC1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724045-5A51-B315-135C-2F4BD7AE3B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C274883-EBE0-7F18-1E48-7E77F6874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EC03046-41EA-82F4-AC58-20E0E8C934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A8C3015-CBC5-5F7E-2E03-2FDB530309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68BD55E-1C1D-0A4A-98AD-9D4795D8E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0B9F38D-119F-8E03-F002-2D5C5839E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066D11A-A4EB-715D-A1DF-4F09E38B2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81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0E91B2-5086-BBF1-1F40-1DFE0F72F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318F30C-3C56-250D-45CE-D71C5525C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494F16-5BA8-F5AB-6933-073439139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1E525A0-A809-B79D-11E5-A6917EF88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545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5242452-4C32-4F65-7F33-3E3352B45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481C41-5B22-7C53-831A-65557A461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1B9C6A-9BAB-41EB-5DDE-CF774F102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0004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0C27FA-1A6C-8791-0C5B-36CC29778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13EF75-4FA1-AE60-2EC1-4D7D4A0611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823158-9D5A-64FC-4123-239CE990B2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B066C8-E7A0-0A94-DBB6-DB661BC7F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E02D209-CB83-5636-AE0A-B0E0D71EB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F5208A-B803-F5A5-05A9-E066BF43F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7896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F17D14-E900-B594-C4A2-0E0AF42BE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8C01175-9188-2295-40AF-80BFFEB444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D699B96-E9DD-93F6-EF72-7050D289D6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E62C75-2203-6532-7E2A-C2EFDF44A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25778BF-FA8B-AEE4-9C5A-FFF24210B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8257F4-D141-3413-FB98-593CCD79F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53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CA36A0D-3F2D-4DA2-FD70-C4BC8AD8F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D6E9CC-C4BD-459F-4527-D08E7195A1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728B0A-6196-9A8B-759C-42E58A4EC1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33D11-AFEE-40D3-9EFC-2187C0E0C652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656119-5798-BFEE-C520-1405D34972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27E043-A574-9E71-8193-76E7D0A6E4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2A58D-F379-42B1-9854-547E4EF074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862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4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FC5968C7-2E29-0DE6-631C-A6D23CE73B69}"/>
              </a:ext>
            </a:extLst>
          </p:cNvPr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3895158030"/>
              </p:ext>
            </p:extLst>
          </p:nvPr>
        </p:nvGraphicFramePr>
        <p:xfrm>
          <a:off x="240613" y="882882"/>
          <a:ext cx="6375400" cy="1764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8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93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42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4946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985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576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Samples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Replicate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aw Reads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lean</a:t>
                      </a:r>
                      <a:r>
                        <a:rPr lang="en-US" altLang="zh-CN" sz="1100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reads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pping rate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igned concordantly exactly 1 time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igned concordantly &gt;1 times 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eaks number</a:t>
                      </a:r>
                    </a:p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P&lt;10</a:t>
                      </a:r>
                      <a:r>
                        <a:rPr lang="en-US" altLang="zh-CN" sz="1100" baseline="300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5</a:t>
                      </a:r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zh-CN" altLang="en-US" sz="1100" i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6,543,715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4,654,85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9.93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.82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9.67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197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zh-CN" altLang="en-US" sz="1100" i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9,846,279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7,080,90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2.03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.70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3.05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658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-Input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i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8,582,603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5,018,696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4.98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2.21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3.96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4,815,43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2,345,99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1.36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.97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1.98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427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8,274,61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5,798,34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1.79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.09%</a:t>
                      </a:r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2.16%</a:t>
                      </a:r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6919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-Input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altLang="zh-CN" sz="11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0,173,763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6,661,77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8.12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4.92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5.39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0808185-1B14-3F2C-2A47-DE5EE52FB675}"/>
              </a:ext>
            </a:extLst>
          </p:cNvPr>
          <p:cNvGraphicFramePr>
            <a:graphicFrameLocks noGrp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238004535"/>
              </p:ext>
            </p:extLst>
          </p:nvPr>
        </p:nvGraphicFramePr>
        <p:xfrm>
          <a:off x="240513" y="3299389"/>
          <a:ext cx="6375600" cy="154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54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31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044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836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597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58437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</a:t>
                      </a:r>
                      <a:endParaRPr lang="zh-CN" altLang="en-US" sz="11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plicate 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aw Reads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lean</a:t>
                      </a:r>
                      <a:r>
                        <a:rPr lang="en-US" altLang="zh-CN" sz="1100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reads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kern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Mapping rate</a:t>
                      </a:r>
                      <a:endParaRPr lang="zh-CN" altLang="en-US" sz="1100" b="1" kern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ranscripts with RPKM&gt;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,123,890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,592,166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1.6% 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,985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,690,713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,089,85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3.0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1,054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  <a:endParaRPr lang="zh-CN" altLang="en-US" sz="11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,175,317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,369,26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1.2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,918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  <a:endParaRPr lang="zh-CN" altLang="en-US" sz="11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1,875,987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,977,586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.3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1,008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EALKBH1</a:t>
                      </a:r>
                      <a:endParaRPr lang="zh-CN" altLang="en-US" sz="11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7,227,89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6,228,08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2.8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1,221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i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EALKBH1</a:t>
                      </a:r>
                      <a:endParaRPr lang="zh-CN" altLang="en-US" sz="11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5,657,103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4,939,01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3.0%</a:t>
                      </a:r>
                      <a:endParaRPr lang="zh-CN" altLang="en-US" sz="11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1,223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1C4A2705-8663-A4EC-F3BB-BD0D364E8249}"/>
              </a:ext>
            </a:extLst>
          </p:cNvPr>
          <p:cNvSpPr txBox="1"/>
          <p:nvPr/>
        </p:nvSpPr>
        <p:spPr>
          <a:xfrm>
            <a:off x="2747092" y="3014432"/>
            <a:ext cx="136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219170"/>
            <a:r>
              <a:rPr lang="en-US" altLang="zh-CN" sz="12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RNA-seq</a:t>
            </a:r>
            <a:endParaRPr lang="zh-CN" altLang="en-US" sz="1200" b="1" dirty="0">
              <a:solidFill>
                <a:prstClr val="black"/>
              </a:solidFill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E5B9536-27F8-6C24-51D8-C16B078DD106}"/>
              </a:ext>
            </a:extLst>
          </p:cNvPr>
          <p:cNvSpPr txBox="1"/>
          <p:nvPr/>
        </p:nvSpPr>
        <p:spPr>
          <a:xfrm>
            <a:off x="152787" y="185431"/>
            <a:ext cx="51936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1219170"/>
            <a:r>
              <a:rPr lang="en-US" altLang="zh-CN" sz="1200" b="1" dirty="0">
                <a:solidFill>
                  <a:srgbClr val="000000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Supplemental Table S1. </a:t>
            </a:r>
            <a:r>
              <a:rPr lang="en-US" altLang="zh-CN" sz="12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6mA DIP-seq, </a:t>
            </a:r>
            <a:r>
              <a:rPr lang="en-US" altLang="zh-CN" sz="1200" b="1" dirty="0">
                <a:solidFill>
                  <a:srgbClr val="000000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RNA-seq and </a:t>
            </a:r>
            <a:r>
              <a:rPr lang="en-US" altLang="zh-CN" sz="1200" b="1" dirty="0" err="1">
                <a:solidFill>
                  <a:srgbClr val="000000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ChIP</a:t>
            </a:r>
            <a:r>
              <a:rPr lang="en-US" altLang="zh-CN" sz="1200" b="1" dirty="0">
                <a:solidFill>
                  <a:srgbClr val="000000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-seq data summary.</a:t>
            </a:r>
            <a:r>
              <a:rPr lang="en-US" altLang="zh-CN" sz="12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 </a:t>
            </a:r>
            <a:endParaRPr lang="zh-CN" altLang="en-US" sz="1200" b="1" dirty="0">
              <a:solidFill>
                <a:prstClr val="black"/>
              </a:solidFill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BBA897F-5818-3A07-7036-CECB6B88BFF8}"/>
              </a:ext>
            </a:extLst>
          </p:cNvPr>
          <p:cNvSpPr/>
          <p:nvPr/>
        </p:nvSpPr>
        <p:spPr>
          <a:xfrm>
            <a:off x="2929220" y="599830"/>
            <a:ext cx="9981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1219170"/>
            <a:r>
              <a:rPr lang="en-US" altLang="zh-CN" sz="12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6mA DIP-seq </a:t>
            </a:r>
            <a:endParaRPr lang="zh-CN" altLang="en-US" sz="1200" b="1" dirty="0">
              <a:solidFill>
                <a:prstClr val="black"/>
              </a:solidFill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graphicFrame>
        <p:nvGraphicFramePr>
          <p:cNvPr id="11" name="表格 10">
            <a:extLst>
              <a:ext uri="{FF2B5EF4-FFF2-40B4-BE49-F238E27FC236}">
                <a16:creationId xmlns:a16="http://schemas.microsoft.com/office/drawing/2014/main" id="{58D584B7-F920-7E72-05DA-4A87CACDDC43}"/>
              </a:ext>
            </a:extLst>
          </p:cNvPr>
          <p:cNvGraphicFramePr>
            <a:graphicFrameLocks noGrp="1"/>
          </p:cNvGraphicFramePr>
          <p:nvPr>
            <p:custDataLst>
              <p:tags r:id="rId3"/>
            </p:custDataLst>
            <p:extLst>
              <p:ext uri="{D42A27DB-BD31-4B8C-83A1-F6EECF244321}">
                <p14:modId xmlns:p14="http://schemas.microsoft.com/office/powerpoint/2010/main" val="3078153474"/>
              </p:ext>
            </p:extLst>
          </p:nvPr>
        </p:nvGraphicFramePr>
        <p:xfrm>
          <a:off x="240513" y="5646028"/>
          <a:ext cx="6375600" cy="277200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290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5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0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0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08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108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108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96000"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plicate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tibody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3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kern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Raw Reads</a:t>
                      </a:r>
                      <a:endParaRPr lang="zh-CN" altLang="en-US" sz="1100" b="1" kern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lean reads 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Mapping rate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1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Arial Unicode MS"/>
                          <a:cs typeface="Calibri" panose="020F0502020204030204" pitchFamily="34" charset="0"/>
                        </a:rPr>
                        <a:t>Peaks</a:t>
                      </a:r>
                      <a:r>
                        <a:rPr lang="en-US" altLang="zh-CN" sz="1100" b="1" kern="100" baseline="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Arial Unicode MS"/>
                          <a:cs typeface="Calibri" panose="020F0502020204030204" pitchFamily="34" charset="0"/>
                        </a:rPr>
                        <a:t> number</a:t>
                      </a:r>
                      <a:endParaRPr lang="zh-CN" sz="1100" b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ALKBH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5,917,257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3,901,484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42.01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,566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ALKBH1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7,939,969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2,942,630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4.81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,660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sz="1100" b="0" i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  <a:endParaRPr lang="zh-CN" sz="1100" b="0" i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ALKBH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5,792,321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4,957,893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87.44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4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sz="1100" b="0" i="1" kern="12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 </a:t>
                      </a:r>
                      <a:endParaRPr lang="zh-CN" sz="1100" b="0" i="1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Arial Unicode MS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ALKBH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9,697,780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9,144,026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2.28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2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NIP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IgG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34,681,519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32,083,298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31.02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5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NIP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IgG</a:t>
                      </a:r>
                      <a:endParaRPr lang="zh-CN" alt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4,155,926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23,113,309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80.36%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56</a:t>
                      </a:r>
                      <a:endParaRPr lang="zh-CN" sz="1100" b="0" kern="1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,457,56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,996,563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21%</a:t>
                      </a:r>
                      <a:endParaRPr lang="zh-CN" altLang="en-US" sz="110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,20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9,127,06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7,381,647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1.58%</a:t>
                      </a:r>
                      <a:endParaRPr lang="zh-CN" altLang="en-US" sz="110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,61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  <a:endParaRPr lang="en-US" sz="1100" i="1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6,308,23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,788,318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3.63%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,40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lkbh1</a:t>
                      </a:r>
                      <a:endParaRPr lang="en-US" sz="1100" i="1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,380,649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8,690,899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4.45%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,86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IP-Input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altLang="zh-CN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,136,098</a:t>
                      </a:r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,121,161</a:t>
                      </a:r>
                      <a:endParaRPr lang="zh-CN" altLang="en-US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8.16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altLang="zh-CN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i="1" kern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alkbh1-Input</a:t>
                      </a:r>
                      <a:endParaRPr lang="zh-CN" altLang="en-US" sz="1100" i="1" kern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,803,713</a:t>
                      </a:r>
                      <a:endParaRPr lang="zh-CN" altLang="en-US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,841,688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7.46%</a:t>
                      </a:r>
                      <a:endParaRPr lang="zh-CN" altLang="en-US" sz="11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altLang="zh-CN" sz="1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1DA20C37-82DB-562B-F322-5E6811083E03}"/>
              </a:ext>
            </a:extLst>
          </p:cNvPr>
          <p:cNvSpPr txBox="1"/>
          <p:nvPr/>
        </p:nvSpPr>
        <p:spPr>
          <a:xfrm>
            <a:off x="2914931" y="5363651"/>
            <a:ext cx="1026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219170"/>
            <a:r>
              <a:rPr lang="en-US" altLang="zh-CN" sz="1200" b="1" dirty="0" err="1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ChIP</a:t>
            </a:r>
            <a:r>
              <a:rPr lang="en-US" altLang="zh-CN" sz="1200" b="1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seq</a:t>
            </a:r>
            <a:endParaRPr lang="zh-CN" altLang="en-US" sz="1200" b="1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41433739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4d0362cc-c911-4cf2-97ac-51d6eec105a8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f83f150a-d117-4033-9601-72df673ee771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931d1b68-e378-4e1f-a060-044ad1713e56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61</Words>
  <Application>Microsoft Office PowerPoint</Application>
  <PresentationFormat>A4 纸张(210x297 毫米)</PresentationFormat>
  <Paragraphs>18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昕冉</dc:creator>
  <cp:lastModifiedBy>张 昕冉</cp:lastModifiedBy>
  <cp:revision>1</cp:revision>
  <dcterms:created xsi:type="dcterms:W3CDTF">2023-02-07T07:31:58Z</dcterms:created>
  <dcterms:modified xsi:type="dcterms:W3CDTF">2023-02-07T07:47:41Z</dcterms:modified>
</cp:coreProperties>
</file>